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  <p:sldId id="262" r:id="rId3"/>
    <p:sldId id="258" r:id="rId4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50" userDrawn="1">
          <p15:clr>
            <a:srgbClr val="A4A3A4"/>
          </p15:clr>
        </p15:guide>
        <p15:guide id="2" pos="2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wan, Aileen" initials="RA" lastIdx="2" clrIdx="0">
    <p:extLst>
      <p:ext uri="{19B8F6BF-5375-455C-9EA6-DF929625EA0E}">
        <p15:presenceInfo xmlns:p15="http://schemas.microsoft.com/office/powerpoint/2012/main" userId="S-1-5-21-243037206-41955558-561332275-24162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4" d="100"/>
          <a:sy n="84" d="100"/>
        </p:scale>
        <p:origin x="2892" y="102"/>
      </p:cViewPr>
      <p:guideLst>
        <p:guide orient="horz" pos="1950"/>
        <p:guide pos="2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CFF90-A7B9-44D5-8CD8-C6E502F66558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AC126-A2E9-4F05-BA4F-65235D6C63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047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CFF90-A7B9-44D5-8CD8-C6E502F66558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AC126-A2E9-4F05-BA4F-65235D6C63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620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CFF90-A7B9-44D5-8CD8-C6E502F66558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AC126-A2E9-4F05-BA4F-65235D6C63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1532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CFF90-A7B9-44D5-8CD8-C6E502F66558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AC126-A2E9-4F05-BA4F-65235D6C63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703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CFF90-A7B9-44D5-8CD8-C6E502F66558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AC126-A2E9-4F05-BA4F-65235D6C63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6458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CFF90-A7B9-44D5-8CD8-C6E502F66558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AC126-A2E9-4F05-BA4F-65235D6C63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7413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CFF90-A7B9-44D5-8CD8-C6E502F66558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AC126-A2E9-4F05-BA4F-65235D6C63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089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CFF90-A7B9-44D5-8CD8-C6E502F66558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AC126-A2E9-4F05-BA4F-65235D6C63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8758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CFF90-A7B9-44D5-8CD8-C6E502F66558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AC126-A2E9-4F05-BA4F-65235D6C63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8477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CFF90-A7B9-44D5-8CD8-C6E502F66558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AC126-A2E9-4F05-BA4F-65235D6C63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6089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CFF90-A7B9-44D5-8CD8-C6E502F66558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AC126-A2E9-4F05-BA4F-65235D6C63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3511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DCFF90-A7B9-44D5-8CD8-C6E502F66558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0AC126-A2E9-4F05-BA4F-65235D6C63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1708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3809" y="7788135"/>
            <a:ext cx="629939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GB" sz="1200" b="1" dirty="0" smtClean="0"/>
              <a:t>Supplementary Table 1.  </a:t>
            </a:r>
            <a:r>
              <a:rPr lang="en-GB" sz="1200" b="1" dirty="0"/>
              <a:t>PVL of PBMC </a:t>
            </a:r>
            <a:r>
              <a:rPr lang="en-GB" sz="1200" b="1" dirty="0" err="1"/>
              <a:t>gDNA</a:t>
            </a:r>
            <a:r>
              <a:rPr lang="en-GB" sz="1200" b="1" dirty="0"/>
              <a:t> and plasma </a:t>
            </a:r>
            <a:r>
              <a:rPr lang="en-GB" sz="1200" b="1" dirty="0" smtClean="0"/>
              <a:t>cfDNA</a:t>
            </a:r>
          </a:p>
          <a:p>
            <a:pPr fontAlgn="b"/>
            <a:r>
              <a:rPr lang="en-GB" sz="1200" dirty="0"/>
              <a:t>Abbreviations: UI, uninfected control; AC, asymptomatic carrier; HAM, HTLV-associated myelopathy; ATL, adult T cell leukaemia/lymphoma; ATL-NR, diagnosed with ATL and was not in remission at the time the sample was obtained; ATL-R, diagnosed with ATL but was in remission at the time the sample was obtained</a:t>
            </a:r>
            <a:r>
              <a:rPr lang="en-GB" sz="1200" dirty="0" smtClean="0"/>
              <a:t>.</a:t>
            </a:r>
            <a:endParaRPr lang="en-GB" sz="12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52242247"/>
              </p:ext>
            </p:extLst>
          </p:nvPr>
        </p:nvGraphicFramePr>
        <p:xfrm>
          <a:off x="118355" y="54358"/>
          <a:ext cx="6470300" cy="7331985"/>
        </p:xfrm>
        <a:graphic>
          <a:graphicData uri="http://schemas.openxmlformats.org/drawingml/2006/table">
            <a:tbl>
              <a:tblPr/>
              <a:tblGrid>
                <a:gridCol w="1294060">
                  <a:extLst>
                    <a:ext uri="{9D8B030D-6E8A-4147-A177-3AD203B41FA5}">
                      <a16:colId xmlns:a16="http://schemas.microsoft.com/office/drawing/2014/main" val="3577744990"/>
                    </a:ext>
                  </a:extLst>
                </a:gridCol>
                <a:gridCol w="1294060">
                  <a:extLst>
                    <a:ext uri="{9D8B030D-6E8A-4147-A177-3AD203B41FA5}">
                      <a16:colId xmlns:a16="http://schemas.microsoft.com/office/drawing/2014/main" val="1959740573"/>
                    </a:ext>
                  </a:extLst>
                </a:gridCol>
                <a:gridCol w="1294060">
                  <a:extLst>
                    <a:ext uri="{9D8B030D-6E8A-4147-A177-3AD203B41FA5}">
                      <a16:colId xmlns:a16="http://schemas.microsoft.com/office/drawing/2014/main" val="1672620611"/>
                    </a:ext>
                  </a:extLst>
                </a:gridCol>
                <a:gridCol w="1294060">
                  <a:extLst>
                    <a:ext uri="{9D8B030D-6E8A-4147-A177-3AD203B41FA5}">
                      <a16:colId xmlns:a16="http://schemas.microsoft.com/office/drawing/2014/main" val="627432554"/>
                    </a:ext>
                  </a:extLst>
                </a:gridCol>
                <a:gridCol w="1294060">
                  <a:extLst>
                    <a:ext uri="{9D8B030D-6E8A-4147-A177-3AD203B41FA5}">
                      <a16:colId xmlns:a16="http://schemas.microsoft.com/office/drawing/2014/main" val="454792630"/>
                    </a:ext>
                  </a:extLst>
                </a:gridCol>
              </a:tblGrid>
              <a:tr h="95880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oup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D</a:t>
                      </a:r>
                    </a:p>
                  </a:txBody>
                  <a:tcPr marL="3763" marR="3763" marT="376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agnosis</a:t>
                      </a:r>
                    </a:p>
                  </a:txBody>
                  <a:tcPr marL="3763" marR="3763" marT="376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MC gDNA PVL</a:t>
                      </a:r>
                    </a:p>
                  </a:txBody>
                  <a:tcPr marL="3763" marR="3763" marT="376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 cfDNA PVL</a:t>
                      </a:r>
                    </a:p>
                  </a:txBody>
                  <a:tcPr marL="3763" marR="3763" marT="3763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5606975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I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I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6349677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I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I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2062146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I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I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3086192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I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I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6969236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I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I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373576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I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I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80512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3056794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4758643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3284651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3243757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6406823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3336130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6097730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071307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5258735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1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7447228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1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4963693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2426162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4428331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9788367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1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5903827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1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4887453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1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0091527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1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8797100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1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2191799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2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1011731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2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8195392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2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1470974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2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7392993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2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1463984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4031963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1732844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3981764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5139288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6865449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7590875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0287316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909648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6588933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1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7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6123116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1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6179914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4002418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3677221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461632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1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6523068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1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4719385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1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8869935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1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6206565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1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0973362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2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.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17006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2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0772983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.4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0449310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.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9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7609346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.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7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1457912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3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7159193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nic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.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5909602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nic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5845300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nic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7747864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moldering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3869819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225553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1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6436935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8202477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262265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4248258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7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2976611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7568909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nic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0870005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nic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6719456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nic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6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2457958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taneous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0128652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2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0410594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2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6946300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2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339291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2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5300545"/>
                  </a:ext>
                </a:extLst>
              </a:tr>
              <a:tr h="9131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2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5331313"/>
                  </a:ext>
                </a:extLst>
              </a:tr>
              <a:tr h="95880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3763" marR="3763" marT="3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2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613573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78958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98532" y="5321863"/>
            <a:ext cx="6299391" cy="24776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smtClean="0"/>
              <a:t>Supplementary Table 2. </a:t>
            </a:r>
            <a:r>
              <a:rPr lang="en-GB" sz="1200" b="1" dirty="0" smtClean="0"/>
              <a:t>Clinical status of ATL patients</a:t>
            </a:r>
          </a:p>
          <a:p>
            <a:r>
              <a:rPr lang="en-GB" sz="1100" dirty="0"/>
              <a:t>Individuals were allocated to each group based on laboratory or clinical findings on the date the sample was obtained. People were assigned to the 'not in remission' (ATL-NR) group if (a) flow cytometry detected the malignant clone in the blood , (b) the </a:t>
            </a:r>
            <a:r>
              <a:rPr lang="en-GB" sz="1100" dirty="0" err="1"/>
              <a:t>gDNA</a:t>
            </a:r>
            <a:r>
              <a:rPr lang="en-GB" sz="1100" dirty="0"/>
              <a:t> PVL was consistent with high frequencies of malignant cells  in the blood (&gt;10% of PBMC) or (c) in the case of a patients with cutaneous subtype ATL ,if lesions were observed. People were assigned to the 'remission' (ATL-R) group if (a) flow cytometry did not detect the malignant clone in the blood (even in the presence of high PVL) , (b) the </a:t>
            </a:r>
            <a:r>
              <a:rPr lang="en-GB" sz="1100" dirty="0" err="1"/>
              <a:t>gDNA</a:t>
            </a:r>
            <a:r>
              <a:rPr lang="en-GB" sz="1100" dirty="0"/>
              <a:t> PVL was consistent with low frequencies of malignant cells in the blood (&lt;10% of PBMC) or (c) in the case of patients with lymphoma subtype ATL, if lesions were no longer observed. Abbreviations: </a:t>
            </a:r>
            <a:r>
              <a:rPr lang="en-GB" sz="1100" dirty="0" err="1"/>
              <a:t>Allo</a:t>
            </a:r>
            <a:r>
              <a:rPr lang="en-GB" sz="1100" dirty="0"/>
              <a:t>, allogeneic; B+B, </a:t>
            </a:r>
            <a:r>
              <a:rPr lang="en-GB" sz="1100" dirty="0" err="1"/>
              <a:t>bortezomib</a:t>
            </a:r>
            <a:r>
              <a:rPr lang="en-GB" sz="1100" dirty="0"/>
              <a:t> and </a:t>
            </a:r>
            <a:r>
              <a:rPr lang="en-GB" sz="1100" dirty="0" err="1"/>
              <a:t>basiliximab</a:t>
            </a:r>
            <a:r>
              <a:rPr lang="en-GB" sz="1100" dirty="0"/>
              <a:t>; BMT, bone marrow transplant; CHOP, cyclophosphamide, doxorubicin, vincristine and prednisolone; CHOEP, cyclophosphamide, doxorubicin, etoposide, vincristine and prednisone; Ep, Etoposide; IFN, interferon alpha;  LDH, lactate dehydrogenase; PEP-C, prednisone, etoposide, </a:t>
            </a:r>
            <a:r>
              <a:rPr lang="en-GB" sz="1100" dirty="0" err="1"/>
              <a:t>procarbazine</a:t>
            </a:r>
            <a:r>
              <a:rPr lang="en-GB" sz="1100" dirty="0"/>
              <a:t>, and cyclophosphamide; PUVA, psoralen and ultra-violet light; SCT, stem cell transplant;  ZDV, zidovudine. </a:t>
            </a:r>
            <a:endParaRPr lang="en-GB" sz="1100" dirty="0" smtClean="0"/>
          </a:p>
          <a:p>
            <a:endParaRPr lang="en-GB" sz="1100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4152665"/>
              </p:ext>
            </p:extLst>
          </p:nvPr>
        </p:nvGraphicFramePr>
        <p:xfrm>
          <a:off x="198532" y="160547"/>
          <a:ext cx="6454751" cy="4829336"/>
        </p:xfrm>
        <a:graphic>
          <a:graphicData uri="http://schemas.openxmlformats.org/drawingml/2006/table">
            <a:tbl>
              <a:tblPr/>
              <a:tblGrid>
                <a:gridCol w="268217">
                  <a:extLst>
                    <a:ext uri="{9D8B030D-6E8A-4147-A177-3AD203B41FA5}">
                      <a16:colId xmlns:a16="http://schemas.microsoft.com/office/drawing/2014/main" val="3957404823"/>
                    </a:ext>
                  </a:extLst>
                </a:gridCol>
                <a:gridCol w="405421">
                  <a:extLst>
                    <a:ext uri="{9D8B030D-6E8A-4147-A177-3AD203B41FA5}">
                      <a16:colId xmlns:a16="http://schemas.microsoft.com/office/drawing/2014/main" val="1526713317"/>
                    </a:ext>
                  </a:extLst>
                </a:gridCol>
                <a:gridCol w="765561">
                  <a:extLst>
                    <a:ext uri="{9D8B030D-6E8A-4147-A177-3AD203B41FA5}">
                      <a16:colId xmlns:a16="http://schemas.microsoft.com/office/drawing/2014/main" val="476602728"/>
                    </a:ext>
                  </a:extLst>
                </a:gridCol>
                <a:gridCol w="504968">
                  <a:extLst>
                    <a:ext uri="{9D8B030D-6E8A-4147-A177-3AD203B41FA5}">
                      <a16:colId xmlns:a16="http://schemas.microsoft.com/office/drawing/2014/main" val="3752101878"/>
                    </a:ext>
                  </a:extLst>
                </a:gridCol>
                <a:gridCol w="559558">
                  <a:extLst>
                    <a:ext uri="{9D8B030D-6E8A-4147-A177-3AD203B41FA5}">
                      <a16:colId xmlns:a16="http://schemas.microsoft.com/office/drawing/2014/main" val="2517392950"/>
                    </a:ext>
                  </a:extLst>
                </a:gridCol>
                <a:gridCol w="500308">
                  <a:extLst>
                    <a:ext uri="{9D8B030D-6E8A-4147-A177-3AD203B41FA5}">
                      <a16:colId xmlns:a16="http://schemas.microsoft.com/office/drawing/2014/main" val="2333314622"/>
                    </a:ext>
                  </a:extLst>
                </a:gridCol>
                <a:gridCol w="615868">
                  <a:extLst>
                    <a:ext uri="{9D8B030D-6E8A-4147-A177-3AD203B41FA5}">
                      <a16:colId xmlns:a16="http://schemas.microsoft.com/office/drawing/2014/main" val="1143509951"/>
                    </a:ext>
                  </a:extLst>
                </a:gridCol>
                <a:gridCol w="763388">
                  <a:extLst>
                    <a:ext uri="{9D8B030D-6E8A-4147-A177-3AD203B41FA5}">
                      <a16:colId xmlns:a16="http://schemas.microsoft.com/office/drawing/2014/main" val="3745012206"/>
                    </a:ext>
                  </a:extLst>
                </a:gridCol>
                <a:gridCol w="961456">
                  <a:extLst>
                    <a:ext uri="{9D8B030D-6E8A-4147-A177-3AD203B41FA5}">
                      <a16:colId xmlns:a16="http://schemas.microsoft.com/office/drawing/2014/main" val="2477679982"/>
                    </a:ext>
                  </a:extLst>
                </a:gridCol>
                <a:gridCol w="1110006">
                  <a:extLst>
                    <a:ext uri="{9D8B030D-6E8A-4147-A177-3AD203B41FA5}">
                      <a16:colId xmlns:a16="http://schemas.microsoft.com/office/drawing/2014/main" val="4135954840"/>
                    </a:ext>
                  </a:extLst>
                </a:gridCol>
              </a:tblGrid>
              <a:tr h="59604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oup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D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agnosis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MC gDNA PV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cyte count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 cell count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DH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us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vidence for status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 history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5411010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0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6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6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psing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ow cytometry: clone detected in blood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lproate, currently on ZDV+IF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8447610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2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.1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8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2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1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psing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PCR: gDNA PVL high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DV+IFN,B+B,Pep-C, currently on ZDV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071940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3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.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1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2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9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psing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PCR: gDNA PVL high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DV+IFN, CHOP, currently off therapy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1337622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4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0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psing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ow cytometry: clone detected in blood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P, haploidentical SCT, currently on lenalidomine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49136"/>
                  </a:ext>
                </a:extLst>
              </a:tr>
              <a:tr h="173281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nic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.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9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3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ff therapy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PCR: gDNA PVL high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9766128"/>
                  </a:ext>
                </a:extLst>
              </a:tr>
              <a:tr h="197892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6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nic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4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6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1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ding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PCR: gDNA PVL high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rrently on </a:t>
                      </a:r>
                      <a:r>
                        <a:rPr lang="en-GB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DV+IF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3857597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7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nic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7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7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ble disease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ow cytometry: clone detected in blood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rrently on valproate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1434558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8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moldering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6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data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data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data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ff therapy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ow cytometry: clone detected in blood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n compliant on ZDV+IF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1175707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9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8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3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0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n treatment with active disease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ow cytometry: clone detected in blood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rrently on CHOP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3054483"/>
                  </a:ext>
                </a:extLst>
              </a:tr>
              <a:tr h="186649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0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1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2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psing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PCR: gDNA PVL high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EP Ep before </a:t>
                      </a:r>
                      <a:r>
                        <a:rPr lang="en-GB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T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984316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1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8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0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n treatment with active disease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inical observation: Lesions observed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rrently on ZDV+IFN +CHOP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7425753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N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2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9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data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ding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ow cytometry: clone detected in blood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rrently on CHOP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2452166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3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data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data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data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PCR: gDNA PVL consistent with 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 BMT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7463884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4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70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PCR: gDNA PVL consistent with 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DV+IFN, currently off treatment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5117891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9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2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ow cytometry: no disease in blood same date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rrently on ZDV+IF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0197679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6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nic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0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2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6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ow cytometry: no disease in blood same date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DV+IFN, currently off treatment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9929440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7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nic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2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PCR: gDNA PVL consistent with 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+B, Mogamulizumab, currently off treatment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4338394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8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nic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9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9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ow cytometry: no disease in blood same date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P, currently on ZDV+IF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7379489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19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taneous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1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0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inical observation: remission of lesions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rrently on PUVA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062352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20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6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PCR: gDNA PVL consistent with 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P followed by BMT, currently off treatment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1724839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21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8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inical observation:  remission of lesions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P, Valproate, currently off tretment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3965320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22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7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PCR: gDNA PVL consistent with 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T, currently on ZDV+IF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401034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23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data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data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data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ow cytometry: no disease in blood same date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P followed by allo SCT, currently off treatment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5846228"/>
                  </a:ext>
                </a:extLst>
              </a:tr>
              <a:tr h="567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24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2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ow cytometry: no disease in blood same date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EP, allo SCT, currently off treatmet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3932413"/>
                  </a:ext>
                </a:extLst>
              </a:tr>
              <a:tr h="59604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_R</a:t>
                      </a:r>
                    </a:p>
                  </a:txBody>
                  <a:tcPr marL="2838" marR="2838" marT="283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L2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matous ATL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data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data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data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mission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ow cytometry: no disease in blood same date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o</a:t>
                      </a:r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SCT, currently off treatment</a:t>
                      </a:r>
                    </a:p>
                  </a:txBody>
                  <a:tcPr marL="2838" marR="2838" marT="283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77844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424503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6333" y="5474118"/>
            <a:ext cx="6909350" cy="11233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smtClean="0"/>
              <a:t>Supplementary Figure 1. Comparison of plasma cfDNA PVL with PBMC </a:t>
            </a:r>
            <a:r>
              <a:rPr lang="en-GB" sz="1200" b="1" dirty="0" err="1" smtClean="0"/>
              <a:t>gDNA</a:t>
            </a:r>
            <a:r>
              <a:rPr lang="en-GB" sz="1200" b="1" dirty="0" smtClean="0"/>
              <a:t> PVL and stability of cfDNA</a:t>
            </a:r>
            <a:endParaRPr lang="en-GB" sz="1200" b="1" dirty="0"/>
          </a:p>
          <a:p>
            <a:r>
              <a:rPr lang="en-GB" sz="1100" dirty="0" smtClean="0"/>
              <a:t>(A) PBMC </a:t>
            </a:r>
            <a:r>
              <a:rPr lang="en-GB" sz="1100" dirty="0" err="1" smtClean="0"/>
              <a:t>gDNA</a:t>
            </a:r>
            <a:r>
              <a:rPr lang="en-GB" sz="1100" dirty="0" smtClean="0"/>
              <a:t> </a:t>
            </a:r>
            <a:r>
              <a:rPr lang="en-GB" sz="1100" dirty="0"/>
              <a:t>PVL. PVL was calculated with the following formula:  PVL= (Tax copies/GE(HBB 80bp))*100</a:t>
            </a:r>
            <a:r>
              <a:rPr lang="en-GB" sz="1100" dirty="0" smtClean="0"/>
              <a:t>. (B) Ratio of plasma cfDNA PVL: PBMC </a:t>
            </a:r>
            <a:r>
              <a:rPr lang="en-GB" sz="1100" dirty="0" err="1" smtClean="0"/>
              <a:t>gDNA</a:t>
            </a:r>
            <a:r>
              <a:rPr lang="en-GB" sz="1100" dirty="0" smtClean="0"/>
              <a:t> PVL showing that the ATL-NR group had a significantly higher relative plasma cfDNA PVL: PBMC </a:t>
            </a:r>
            <a:r>
              <a:rPr lang="en-GB" sz="1100" dirty="0" err="1" smtClean="0"/>
              <a:t>gDNA</a:t>
            </a:r>
            <a:r>
              <a:rPr lang="en-GB" sz="1100" dirty="0" smtClean="0"/>
              <a:t> PVL than ACs and patients with HAM. (C) Comparison of GE/ml plasma in cfDNA extracted immediately from plasma and extracted after 4 years storage of plasma at -80°C. </a:t>
            </a:r>
            <a:r>
              <a:rPr lang="en-GB" sz="1100" dirty="0"/>
              <a:t>Statistical tests: </a:t>
            </a:r>
            <a:r>
              <a:rPr lang="en-GB" sz="1100" dirty="0" smtClean="0"/>
              <a:t>(A and B) </a:t>
            </a:r>
            <a:r>
              <a:rPr lang="en-GB" sz="1100" dirty="0" err="1" smtClean="0"/>
              <a:t>Kruskal</a:t>
            </a:r>
            <a:r>
              <a:rPr lang="en-GB" sz="1100" dirty="0" smtClean="0"/>
              <a:t>-Wallis </a:t>
            </a:r>
            <a:r>
              <a:rPr lang="en-GB" sz="1100" dirty="0"/>
              <a:t>with Dunn’s multiple comparisons test (two-tailed, 95% confidence interval, </a:t>
            </a:r>
            <a:r>
              <a:rPr lang="en-GB" sz="1100" dirty="0" err="1"/>
              <a:t>GraphPad</a:t>
            </a:r>
            <a:r>
              <a:rPr lang="en-GB" sz="1100" dirty="0"/>
              <a:t> Prism). </a:t>
            </a:r>
            <a:endParaRPr lang="en-GB" sz="1200" dirty="0"/>
          </a:p>
        </p:txBody>
      </p:sp>
      <p:sp>
        <p:nvSpPr>
          <p:cNvPr id="4" name="TextBox 3"/>
          <p:cNvSpPr txBox="1"/>
          <p:nvPr/>
        </p:nvSpPr>
        <p:spPr>
          <a:xfrm>
            <a:off x="348700" y="59937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353753" y="599379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9862174"/>
              </p:ext>
            </p:extLst>
          </p:nvPr>
        </p:nvGraphicFramePr>
        <p:xfrm>
          <a:off x="1682750" y="3421063"/>
          <a:ext cx="2835275" cy="2081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34" name="Prism 9" r:id="rId3" imgW="4047925" imgH="2973072" progId="Prism9.Document">
                  <p:embed/>
                </p:oleObj>
              </mc:Choice>
              <mc:Fallback>
                <p:oleObj name="Prism 9" r:id="rId3" imgW="4047925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82750" y="3421063"/>
                        <a:ext cx="2835275" cy="2081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348700" y="312911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</a:t>
            </a:r>
            <a:endParaRPr lang="en-GB" b="1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8175698"/>
              </p:ext>
            </p:extLst>
          </p:nvPr>
        </p:nvGraphicFramePr>
        <p:xfrm>
          <a:off x="709116" y="214881"/>
          <a:ext cx="2503556" cy="28314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35" name="Prism 9" r:id="rId5" imgW="3576508" imgH="4044890" progId="Prism9.Document">
                  <p:embed/>
                </p:oleObj>
              </mc:Choice>
              <mc:Fallback>
                <p:oleObj name="Prism 9" r:id="rId5" imgW="3576508" imgH="404489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09116" y="214881"/>
                        <a:ext cx="2503556" cy="28314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5422331"/>
              </p:ext>
            </p:extLst>
          </p:nvPr>
        </p:nvGraphicFramePr>
        <p:xfrm>
          <a:off x="3792597" y="952297"/>
          <a:ext cx="2657334" cy="20940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36" name="Prism 9" r:id="rId7" imgW="3796191" imgH="2991439" progId="Prism9.Document">
                  <p:embed/>
                </p:oleObj>
              </mc:Choice>
              <mc:Fallback>
                <p:oleObj name="Prism 9" r:id="rId7" imgW="3796191" imgH="299143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792597" y="952297"/>
                        <a:ext cx="2657334" cy="20940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511924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eme1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heme1" id="{AF188755-922E-40EE-BDCD-D25A847447B1}" vid="{86F4232F-6425-45EB-A5AD-DA86C505257E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9201</TotalTime>
  <Words>1439</Words>
  <Application>Microsoft Office PowerPoint</Application>
  <PresentationFormat>On-screen Show (4:3)</PresentationFormat>
  <Paragraphs>654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heme1</vt:lpstr>
      <vt:lpstr>Prism 9</vt:lpstr>
      <vt:lpstr>PowerPoint Presentation</vt:lpstr>
      <vt:lpstr>PowerPoint Presentation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wan, Aileen</dc:creator>
  <cp:lastModifiedBy>Rowan, Aileen</cp:lastModifiedBy>
  <cp:revision>147</cp:revision>
  <cp:lastPrinted>2023-03-13T14:10:16Z</cp:lastPrinted>
  <dcterms:created xsi:type="dcterms:W3CDTF">2018-09-06T09:47:15Z</dcterms:created>
  <dcterms:modified xsi:type="dcterms:W3CDTF">2023-03-13T15:33:39Z</dcterms:modified>
</cp:coreProperties>
</file>